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67"/>
    <p:restoredTop sz="94651"/>
  </p:normalViewPr>
  <p:slideViewPr>
    <p:cSldViewPr snapToGrid="0">
      <p:cViewPr varScale="1">
        <p:scale>
          <a:sx n="101" d="100"/>
          <a:sy n="101" d="100"/>
        </p:scale>
        <p:origin x="6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015C1A-AA65-A4F7-C95D-6DB4E9FD50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CB961B0-2F89-BFCD-EDC0-2085AC6712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0F6D21-A323-95FF-9CBD-3E4116D48C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655131-F475-841D-69F2-76472EBE80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DD0A63-95EA-2963-E068-AC07CCAE7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438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43ADB1-AE15-7FD5-D2E1-4F9C9B6750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4DF0C93-C07B-C0A8-A865-2D47510F07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B614A9-3E27-55FF-7FB2-CD0E0652E4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AB159B-F8E5-4AA6-1424-E7E0C7970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4F07FA-EE6F-F785-AE2B-43E92113E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119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117B8E0-F641-3006-B4FC-BFD2C4417C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79DEDE-39E8-A6F3-E81E-6522DDEAD1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762C91-5100-A432-C899-5A7608B8D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734E19-FBAA-27F0-188F-AFD0570CA8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C06FA8-16FF-7756-EC97-91A65F39B2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14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1EEAF4-BF11-7517-D562-7EEEFB6044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171673-46C5-DAE3-A9C7-AA59AFCBB1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BD4874-6560-7185-B9CC-9D39CD8BC7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6CFDED-7447-E72C-71FD-BD68698732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8CBA09-20AC-7446-57D6-6F230EA71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432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7A33F8-2794-F1B1-A457-E9EB5341DA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D8158F-C946-0CE3-E736-9F9D787332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7E3AE9-41F7-0E42-E239-8665976AB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7B99F5-D1C1-151E-8A7E-BEA6A7673A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996AC4-F606-D3FC-ED5B-A503556F6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262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624C16-D4F8-DD46-07C6-E042439D75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4C2EDA-B4A0-1732-F621-A6AA21D8F92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F92D2D-E34F-C2B2-202D-BD6EB4139F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BAFF6D-A2FB-431A-A4AB-11C39D077C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211D4E-1D87-B482-05B9-006964DFA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E4D431-A2B3-62B9-6872-08C9E3E9B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535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E7552D-A294-9F66-AB27-A96ADA8EFD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EB2370-DA03-764D-8491-6F3C104688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2E16FFE-A3C2-B8D0-675A-4DF21278CF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F3C273-97C7-62A4-DE82-6F84A63A0A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C2D63A3-04E1-B771-30B2-A03175B9961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7E16DB9-805A-060F-A14B-9E8568064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E11D4E9-EC49-889E-FADF-91E124433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3F7C03-4A04-6572-9999-88F2ADDC6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4133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6B783B-3940-B684-812E-DE232EFDE7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3CB7332-AA54-8283-66F2-0EAEC9E620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5DE2813-214E-8D0E-08A8-4825C97941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A17761-6E98-49D8-FEBC-89C212B43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361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C053AB3-61CE-08E2-DF18-3D2002D17D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6CD08E-38D0-5E3D-33A4-A7B1590FE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4E79CAB-851E-A75B-E026-343C25840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3005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02006A-CB82-CDFE-3EE1-381149B530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F9E485-2611-E713-F4D0-A5D6D97B7D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A24654-57B1-798C-77BE-EB0CD82223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7F6325-EF5E-520F-9DAE-BE60B33D8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CFEF75-9D15-C448-E16C-F6FC437FA2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38A39C-2001-0838-5681-32289CD3F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376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BF0F0C-7C20-4664-C19B-C9AB7F87A0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E3FA0C-94D5-A862-0F7A-F96ABF721D4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BE6FCF-6AF6-7186-6FF4-C0B843AB61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7EB490-F8E9-9ECA-AEDA-6418D83649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CA57F3-99A8-6395-2D29-DD4A12BB5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C32701-E1FD-3288-AC49-D56E43C5C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820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4BCD452-FB62-4646-C06A-FB9839FBC7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3E70C9-1E7C-931E-24FA-AC392E2589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7183AC-BBC0-970B-18FB-13D6AEC52C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D9D63B1-1818-934C-B4AC-71A4F02B8CFE}" type="datetimeFigureOut">
              <a:rPr lang="en-US" smtClean="0"/>
              <a:t>4/13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A003FA-5337-937D-42BA-D470281837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270673-378F-8A57-216D-BA3AA571C3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ACBBF0-D445-8540-AC64-356D23228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600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F5B4EC0-B112-37D2-038B-B9C7EF69A7D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6910883"/>
              </p:ext>
            </p:extLst>
          </p:nvPr>
        </p:nvGraphicFramePr>
        <p:xfrm>
          <a:off x="1035050" y="1574831"/>
          <a:ext cx="10121900" cy="370833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61179">
                  <a:extLst>
                    <a:ext uri="{9D8B030D-6E8A-4147-A177-3AD203B41FA5}">
                      <a16:colId xmlns:a16="http://schemas.microsoft.com/office/drawing/2014/main" val="4135110594"/>
                    </a:ext>
                  </a:extLst>
                </a:gridCol>
                <a:gridCol w="4384352">
                  <a:extLst>
                    <a:ext uri="{9D8B030D-6E8A-4147-A177-3AD203B41FA5}">
                      <a16:colId xmlns:a16="http://schemas.microsoft.com/office/drawing/2014/main" val="3437917861"/>
                    </a:ext>
                  </a:extLst>
                </a:gridCol>
                <a:gridCol w="4476369">
                  <a:extLst>
                    <a:ext uri="{9D8B030D-6E8A-4147-A177-3AD203B41FA5}">
                      <a16:colId xmlns:a16="http://schemas.microsoft.com/office/drawing/2014/main" val="2607327814"/>
                    </a:ext>
                  </a:extLst>
                </a:gridCol>
              </a:tblGrid>
              <a:tr h="42926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Forward 3’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 Reverse 3’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2750259"/>
                  </a:ext>
                </a:extLst>
              </a:tr>
              <a:tr h="42926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 TCC TCT GAC TTC AAC AGC G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 ACC CTG TTG CTG TAG CCA A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5575752"/>
                  </a:ext>
                </a:extLst>
              </a:tr>
              <a:tr h="42926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21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 TGG ACC TGG AGA CTC TCA G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 TCT TGG AGA AGA TCA GCC G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2465858"/>
                  </a:ext>
                </a:extLst>
              </a:tr>
              <a:tr h="42926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L5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 GCT GCT TTG CCT ACA TTG C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 CAC TTG GCG GTT CTT TCG G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9529381"/>
                  </a:ext>
                </a:extLst>
              </a:tr>
              <a:tr h="42926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XCL10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 GAG AAG AGA TGT CTG AAT CC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 CAT CCT TGG AAG CAC TGC A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8102774"/>
                  </a:ext>
                </a:extLst>
              </a:tr>
              <a:tr h="42926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1</a:t>
                      </a: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itchFamily="2" charset="2"/>
                        </a:rPr>
                        <a:t>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 CAG ACC TTC CAG GAG AAT G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 CAG TTC AGT GAT CGT ACA GG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9385416"/>
                  </a:ext>
                </a:extLst>
              </a:tr>
              <a:tr h="42926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6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 CAG CCA CTC ACC TCT TCA G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 TGC CAG TGC CTC TTT GCT G</a:t>
                      </a:r>
                      <a:endParaRPr lang="en-US" sz="1800" kern="1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2047563"/>
                  </a:ext>
                </a:extLst>
              </a:tr>
              <a:tr h="429264"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OP2</a:t>
                      </a:r>
                      <a:endParaRPr lang="en-US" sz="1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 CAT CAA GGG CGA GTC TCT A</a:t>
                      </a:r>
                      <a:endParaRPr lang="en-US" sz="1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US" sz="18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 CGC TTC ATG GAG AAC TTC G</a:t>
                      </a:r>
                      <a:endParaRPr lang="en-US" sz="18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Aptos" panose="020B00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7256441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2FEF1914-8D03-BFAE-A478-C623255555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7781925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ry Table 1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rimer sequences for qPCR in this study</a:t>
            </a:r>
            <a:endParaRPr kumimoji="0" lang="en-US" altLang="en-US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27583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8</TotalTime>
  <Words>141</Words>
  <Application>Microsoft Macintosh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Data</dc:title>
  <dc:creator>Natalie Luffman</dc:creator>
  <cp:lastModifiedBy>Natalie Luffman</cp:lastModifiedBy>
  <cp:revision>7</cp:revision>
  <dcterms:created xsi:type="dcterms:W3CDTF">2026-04-11T22:12:36Z</dcterms:created>
  <dcterms:modified xsi:type="dcterms:W3CDTF">2026-04-13T15:39:03Z</dcterms:modified>
</cp:coreProperties>
</file>